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5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4" autoAdjust="0"/>
    <p:restoredTop sz="94660"/>
  </p:normalViewPr>
  <p:slideViewPr>
    <p:cSldViewPr snapToGrid="0">
      <p:cViewPr varScale="1">
        <p:scale>
          <a:sx n="86" d="100"/>
          <a:sy n="86" d="100"/>
        </p:scale>
        <p:origin x="65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4A124C-8BA8-545A-F057-C1520E5DFE6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0650F6F-92E4-E35C-1CAE-61E0718E8F7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8F5B38-F756-E81A-3A2C-AF429EF2F3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4D3EC-5CC3-422C-B097-E1FB8F02C547}" type="datetimeFigureOut">
              <a:rPr lang="en-US" smtClean="0"/>
              <a:t>3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803768-39BF-3CC9-3C6F-4D8332FDB7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ADF7E43-5FCC-022E-25AF-920F1C2A7C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DA3955-41F7-4814-90D4-56458736A5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36262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F047A2-1C25-5E00-10EE-4C71829C6C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DACEFF3-5B93-13A9-7245-AAA88860006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56C214-171E-9D86-D343-4AA6967BC4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4D3EC-5CC3-422C-B097-E1FB8F02C547}" type="datetimeFigureOut">
              <a:rPr lang="en-US" smtClean="0"/>
              <a:t>3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721C20-5504-77C8-7EA0-1BF532D83A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7D5740-C83B-85EB-5AC2-4557B5029C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DA3955-41F7-4814-90D4-56458736A5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79908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97EDECF-5FA9-4C56-EBA7-E56EA0CBBC8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9312972-373F-8CF2-A5D4-8455E19872B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34B96B-BA56-4F47-D6B3-3DACDCED34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4D3EC-5CC3-422C-B097-E1FB8F02C547}" type="datetimeFigureOut">
              <a:rPr lang="en-US" smtClean="0"/>
              <a:t>3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B92333C-8ADC-22E7-39A6-421374310A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B2A983-E889-7A3C-3315-86846F28E0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DA3955-41F7-4814-90D4-56458736A5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23051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9DF6ED-B096-BAE4-243E-DB14370D59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889C97C-8934-A5E7-578B-0FFF8170C02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0117BD-CFC5-5E2B-9C84-0F14A71A91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4D3EC-5CC3-422C-B097-E1FB8F02C547}" type="datetimeFigureOut">
              <a:rPr lang="en-US" smtClean="0"/>
              <a:t>3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D49162-20DB-9993-705D-A4AEE97331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C57876-9C15-48B8-E96E-B6C632D12B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DA3955-41F7-4814-90D4-56458736A5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55856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979108-7B88-C864-F801-541A194216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A3E8AC4-C261-F647-ED41-14D14D8317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E50C35-8137-9B35-2286-7DEB1AFD6E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4D3EC-5CC3-422C-B097-E1FB8F02C547}" type="datetimeFigureOut">
              <a:rPr lang="en-US" smtClean="0"/>
              <a:t>3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877E6D-BB03-D39D-4AF7-248ECCA0DB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1E4CD0-8C0A-168D-279F-A214A51968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DA3955-41F7-4814-90D4-56458736A5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41887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752B5C-9FB0-2FDD-D5A2-5EF2AE8A40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96CE5C-7956-0C55-6026-49F2D634A10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954D83A-3994-0EC1-BC3D-045E459075E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EB1B86C-7517-C747-0F9A-338EFCC8CF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4D3EC-5CC3-422C-B097-E1FB8F02C547}" type="datetimeFigureOut">
              <a:rPr lang="en-US" smtClean="0"/>
              <a:t>3/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C36D2B0-8520-47F5-BFC0-ECD16111C5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E2D2F71-B7CA-7B7E-8626-4462EECF88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DA3955-41F7-4814-90D4-56458736A5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65649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892A10-BCB5-A08D-897E-EBC96D971A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C90A0C1-375F-B47D-A351-2193697C50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C9E43FE-E756-BAA9-6B7F-E5FABD8910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F3397E6-A975-C0A3-9488-77CC8575153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F9BE692-A42F-0DDD-FD8E-751EA3CA135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C5ED61E-E8FD-A7F0-8A27-E7F6096CB2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4D3EC-5CC3-422C-B097-E1FB8F02C547}" type="datetimeFigureOut">
              <a:rPr lang="en-US" smtClean="0"/>
              <a:t>3/1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39F4FE6-064B-DC9E-6DD5-B2F37E2032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23F659E-29CF-027F-D83B-6D92911442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DA3955-41F7-4814-90D4-56458736A5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73522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5D7FDD-381A-0C8A-1CD8-BF2874037C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2586BFB-38D1-DD58-8AFD-561F7BDB01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4D3EC-5CC3-422C-B097-E1FB8F02C547}" type="datetimeFigureOut">
              <a:rPr lang="en-US" smtClean="0"/>
              <a:t>3/1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CF97AE4-EC9F-5367-D570-D745723C49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9664AB9-0A83-1191-9469-D3B06B91D9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DA3955-41F7-4814-90D4-56458736A5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64950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19901DE-562E-8304-B11E-6502FE5D70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4D3EC-5CC3-422C-B097-E1FB8F02C547}" type="datetimeFigureOut">
              <a:rPr lang="en-US" smtClean="0"/>
              <a:t>3/1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27A78B2-16AA-4E8E-A24E-65A3867A0A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B9F9192-1906-6370-6BAB-1088F08AD7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DA3955-41F7-4814-90D4-56458736A5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62020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557859-1BBC-37E7-CD8A-B63E134784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BF5A12C-0810-89AD-71C7-8F6339BEE30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A9EBD71-0753-4DCB-D49A-8E656436854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22AD97B-CF25-F2FC-0E82-595068D441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4D3EC-5CC3-422C-B097-E1FB8F02C547}" type="datetimeFigureOut">
              <a:rPr lang="en-US" smtClean="0"/>
              <a:t>3/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F921DC5-C2A3-666E-6971-8982537110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9ADCCF3-29C6-F98E-531E-92DAEB44AC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DA3955-41F7-4814-90D4-56458736A5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71588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8F71CE-851E-5673-D9D2-8229A0E072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8717588-84BD-2D56-116A-FE3253EC135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45470A3-F435-7AC6-67CA-698A35B0E9C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C0300F9-217A-4E95-13EF-05CEE9BC87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4D3EC-5CC3-422C-B097-E1FB8F02C547}" type="datetimeFigureOut">
              <a:rPr lang="en-US" smtClean="0"/>
              <a:t>3/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61881F3-B37A-FFDF-DC5C-8BB76EB982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A2BF0C8-7405-6592-CA34-F30D219FFC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DA3955-41F7-4814-90D4-56458736A5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01896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AD4C821-1968-9BD3-5C2E-4A89706500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03A7D02-4424-90F6-4758-AF434C3210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6BC530-38F8-BB58-60C5-68B23D7C4D3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4D3EC-5CC3-422C-B097-E1FB8F02C547}" type="datetimeFigureOut">
              <a:rPr lang="en-US" smtClean="0"/>
              <a:t>3/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AF1484-7CBE-053A-3F30-4853F78B346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CE8A6D-CE11-B4D2-85BC-97E8DF36794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DA3955-41F7-4814-90D4-56458736A5E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13367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2C80E3D-C514-DED2-A775-FE5FF7BB20F9}"/>
              </a:ext>
            </a:extLst>
          </p:cNvPr>
          <p:cNvSpPr txBox="1"/>
          <p:nvPr/>
        </p:nvSpPr>
        <p:spPr>
          <a:xfrm>
            <a:off x="62287" y="73349"/>
            <a:ext cx="11640615" cy="46166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4: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u="sng" dirty="0">
                <a:latin typeface="Arial" panose="020B0604020202020204" pitchFamily="34" charset="0"/>
                <a:cs typeface="Arial" panose="020B0604020202020204" pitchFamily="34" charset="0"/>
              </a:rPr>
              <a:t>Kinetics of CBD on GRAB</a:t>
            </a:r>
            <a:r>
              <a:rPr lang="en-US" sz="1200" u="sng" baseline="-25000" dirty="0">
                <a:latin typeface="Arial" panose="020B0604020202020204" pitchFamily="34" charset="0"/>
                <a:cs typeface="Arial" panose="020B0604020202020204" pitchFamily="34" charset="0"/>
              </a:rPr>
              <a:t>eCB2.0</a:t>
            </a:r>
            <a:r>
              <a:rPr lang="en-US" sz="1200" u="sng" dirty="0">
                <a:latin typeface="Arial" panose="020B0604020202020204" pitchFamily="34" charset="0"/>
                <a:cs typeface="Arial" panose="020B0604020202020204" pitchFamily="34" charset="0"/>
              </a:rPr>
              <a:t> signal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CBD does not significantly activate the GRABeCB2.0 as measured by the high throughput assay. n = 3-6 independent experiments performed in triplicate.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E9F75BAE-C077-835F-0C76-5B16540AF88B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441721" y="1826802"/>
          <a:ext cx="2860510" cy="266001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2966798" imgH="2758681" progId="Prism9.Document">
                  <p:embed/>
                </p:oleObj>
              </mc:Choice>
              <mc:Fallback>
                <p:oleObj name="Prism 9" r:id="rId2" imgW="2966798" imgH="2758681" progId="Prism9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E9F75BAE-C077-835F-0C76-5B16540AF88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441721" y="1826802"/>
                        <a:ext cx="2860510" cy="266001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3634969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5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9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lla_lab8</dc:creator>
  <cp:lastModifiedBy>stella_lab8</cp:lastModifiedBy>
  <cp:revision>2</cp:revision>
  <dcterms:created xsi:type="dcterms:W3CDTF">2023-03-02T03:05:37Z</dcterms:created>
  <dcterms:modified xsi:type="dcterms:W3CDTF">2023-03-02T03:06:48Z</dcterms:modified>
</cp:coreProperties>
</file>